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7" r:id="rId2"/>
    <p:sldId id="264" r:id="rId3"/>
    <p:sldId id="265" r:id="rId4"/>
    <p:sldId id="258" r:id="rId5"/>
    <p:sldId id="263" r:id="rId6"/>
    <p:sldId id="260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658" autoAdjust="0"/>
    <p:restoredTop sz="93783" autoAdjust="0"/>
  </p:normalViewPr>
  <p:slideViewPr>
    <p:cSldViewPr snapToGrid="0">
      <p:cViewPr varScale="1">
        <p:scale>
          <a:sx n="64" d="100"/>
          <a:sy n="64" d="100"/>
        </p:scale>
        <p:origin x="76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BA9EAA7-A3BA-4C83-812F-67B8FD5780CD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3EAE3C-EC40-4EEC-8CD4-29133A75978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13203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94078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10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012111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ure 10E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18151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11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926797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12C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313333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13F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43EAE3C-EC40-4EEC-8CD4-29133A759788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24873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657FA8-C5E3-5E2A-3204-AA1BB1D50B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2AED7AE-B0A0-B97E-CF8A-098891FF1E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656A6AB-ADB8-3692-A897-9F551D666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C85F494-C2A1-2B55-5DA7-129A5F6EC3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CB6B80-0481-6730-E87D-0BC391807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87311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9E52246-873D-5C6E-0793-0EA67B10C19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29FC326-A40B-0EFE-3B6D-2A969154FE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01AD70-3277-4635-2871-C5CB7E4AA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67A3FC-E773-08CC-68A9-93D88353CB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EA6BBEE-C86E-A439-9E51-1776D6794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42384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4EF33B6-CF31-2DF3-26BF-13049C001A1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1E691F-1E5D-D0AE-EBA6-EEB58526F8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76FB2F-FE6F-871F-EEED-8E6A13960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B041DD0-749F-AD31-6833-6A10D3CDF9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135DAD2-21F3-3C67-4EF3-3BCA0D55A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6801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515C3B-5AF1-0EB1-9F41-E8FAF57990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77100DE-5D8B-37D2-4DBF-16169796FA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B809A2D-886F-2458-83E6-9C07A619F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083A46-78A8-82CC-8881-CA91B0466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404965-3B73-B553-7C37-EBB6EE3DB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8041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304ACED-2E0A-CA91-CCAA-453F30DC8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905DA80-F9CA-EB64-A49B-A7B11EDA9E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6E674F-C51A-66AB-96B8-35F3D366C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F97C93-E20C-5975-28A7-F80B0C5FB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5EE96D-25A5-CC8B-E7BA-3BD1E9AA2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943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B058B8-8F98-35EE-1A88-A1B8825932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F64A388-946B-4D7E-470A-957846D04C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FF315AF-67C9-7535-679B-3DE5581EFA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BF9F9FF-105D-2F48-E151-2086530E0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C987986-5D17-C352-C21B-E282154C05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CD1DBAF-5DDD-9833-E6F2-64092DFA0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0888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570F2E-70FD-42C4-56AC-EA304D60F8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6719204-6FEB-A68F-F204-C5B7374C89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8A1571D-D9E4-57FC-B6DE-BC3F1D90916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8884AB8F-750B-EF24-4DDD-20A5405F66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DB8E246-F343-6B92-015E-BD5B80C85B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EC2E59F8-6008-FEE3-5B05-3499C48B36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7604E33-EB22-B31A-E4A0-0625CB04D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302B949-E570-D4EE-CD12-410A5E5BC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141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B1D2CAF-C4EC-B1E1-62F9-95AB1DACD7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782EE1A-AD9A-A2D1-F589-66555069A9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E849D8F-6485-B81C-F7AB-8CA18A0DDF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29FDFF-B13A-02E0-F4A7-39CC323627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515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574EF612-CFD5-75CF-0467-7AD760C54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5C250F0-C649-1AD4-FDF5-F1FD4F2B4A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BE0B884-EEEC-FDCA-BC7D-8706D290E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61142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6ADDEB-9A53-35E6-91E8-B0E6C9D7F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3AC1AF6-5AE2-6B7F-FFBB-AF78900C16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D1C6BE2-DC4B-BE86-ADCD-FEFC27FBC4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3F98143-1A50-1584-0F25-5EF64E744D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6330754-554A-6962-E1C4-5822DAB8A4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95198C9-D219-9CCB-758F-C42BA0FF16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0365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607EAA0-B27E-BB96-923F-1CF27CB743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6C01F80-C0B6-F863-0B72-934BCFA5F1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CC59A0B-3C7E-8214-733D-119FB766E2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93F73F-558C-643B-CFDA-7766A42A8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7CFC12A-708B-13B8-BE95-301CD7B64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A1A212C-D2D4-72E2-7E6F-E5020E544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0806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02216BF-7EF3-056E-3F98-E10DD634BF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9F17AD5-C618-7054-35AE-CCD1B3E53E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3195E19-477E-85D9-3273-60AB8E1CC6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E0C24-9DB4-403A-B942-64A254EDF1A3}" type="datetimeFigureOut">
              <a:rPr lang="zh-CN" altLang="en-US" smtClean="0"/>
              <a:t>2023/7/2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6EAA77-45CB-BEDF-98EF-585C9294DC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494A840-9C98-7823-F8B9-BFD7560718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B4F565-3C4D-4738-8A41-B76954E63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0776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jpg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3" Type="http://schemas.openxmlformats.org/officeDocument/2006/relationships/image" Target="../media/image8.jpg"/><Relationship Id="rId7" Type="http://schemas.openxmlformats.org/officeDocument/2006/relationships/image" Target="../media/image12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jpg"/><Relationship Id="rId5" Type="http://schemas.openxmlformats.org/officeDocument/2006/relationships/image" Target="../media/image16.jpg"/><Relationship Id="rId4" Type="http://schemas.openxmlformats.org/officeDocument/2006/relationships/image" Target="../media/image15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6.jpg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42F91B63-4CFC-4E93-61C4-6A91FFD86A3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14" r="18469" b="63261"/>
          <a:stretch/>
        </p:blipFill>
        <p:spPr>
          <a:xfrm>
            <a:off x="3793429" y="4258911"/>
            <a:ext cx="3369365" cy="2519569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5693F427-6EF4-CB3E-77B0-0E8E16170C28}"/>
              </a:ext>
            </a:extLst>
          </p:cNvPr>
          <p:cNvSpPr/>
          <p:nvPr/>
        </p:nvSpPr>
        <p:spPr>
          <a:xfrm>
            <a:off x="3998624" y="5951453"/>
            <a:ext cx="1361661" cy="558426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F01CEAF3-6115-9F60-D6BC-0FA14AED23A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496" t="46305" r="16685" b="34130"/>
          <a:stretch/>
        </p:blipFill>
        <p:spPr>
          <a:xfrm>
            <a:off x="3793429" y="3390969"/>
            <a:ext cx="3329609" cy="1341782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40690689-900A-BD51-FCFF-8228778C1844}"/>
              </a:ext>
            </a:extLst>
          </p:cNvPr>
          <p:cNvSpPr/>
          <p:nvPr/>
        </p:nvSpPr>
        <p:spPr>
          <a:xfrm>
            <a:off x="4096573" y="3477735"/>
            <a:ext cx="1361661" cy="558426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86141F59-CA43-4EE4-2F5C-FB9D47EE64F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22" t="30159" r="19464" b="20710"/>
          <a:stretch/>
        </p:blipFill>
        <p:spPr>
          <a:xfrm>
            <a:off x="3543293" y="21602"/>
            <a:ext cx="3414091" cy="336936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E383B4AC-35D8-4C11-6557-6D3FB3DFE25C}"/>
              </a:ext>
            </a:extLst>
          </p:cNvPr>
          <p:cNvSpPr txBox="1"/>
          <p:nvPr/>
        </p:nvSpPr>
        <p:spPr>
          <a:xfrm>
            <a:off x="1213563" y="533380"/>
            <a:ext cx="1257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10A</a:t>
            </a: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7AC0C006-2149-D33D-4A7C-CE49A0DFB753}"/>
              </a:ext>
            </a:extLst>
          </p:cNvPr>
          <p:cNvSpPr/>
          <p:nvPr/>
        </p:nvSpPr>
        <p:spPr>
          <a:xfrm>
            <a:off x="4937064" y="1382280"/>
            <a:ext cx="1361661" cy="558426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id="{B9A5D3EB-2537-9D2D-1CE2-A90960DE342D}"/>
              </a:ext>
            </a:extLst>
          </p:cNvPr>
          <p:cNvSpPr/>
          <p:nvPr/>
        </p:nvSpPr>
        <p:spPr>
          <a:xfrm>
            <a:off x="3951319" y="2603315"/>
            <a:ext cx="1361661" cy="558426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A9CBA68-5793-FECD-5072-B32C9D3B5013}"/>
              </a:ext>
            </a:extLst>
          </p:cNvPr>
          <p:cNvSpPr txBox="1"/>
          <p:nvPr/>
        </p:nvSpPr>
        <p:spPr>
          <a:xfrm>
            <a:off x="7058434" y="1382280"/>
            <a:ext cx="2844048" cy="507831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MFN2 </a:t>
            </a:r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r>
              <a:rPr lang="en-US" altLang="zh-CN" dirty="0"/>
              <a:t>NRF2                                  </a:t>
            </a:r>
          </a:p>
          <a:p>
            <a:r>
              <a:rPr lang="en-US" altLang="zh-CN" dirty="0"/>
              <a:t>                </a:t>
            </a:r>
          </a:p>
          <a:p>
            <a:endParaRPr lang="en-US" altLang="zh-CN" dirty="0"/>
          </a:p>
          <a:p>
            <a:endParaRPr lang="en-US" altLang="zh-CN" dirty="0"/>
          </a:p>
          <a:p>
            <a:r>
              <a:rPr lang="en-US" altLang="zh-CN" dirty="0"/>
              <a:t>CSE</a:t>
            </a:r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endParaRPr lang="en-US" altLang="zh-CN" dirty="0"/>
          </a:p>
          <a:p>
            <a:r>
              <a:rPr lang="en-US" altLang="zh-CN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339081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>
            <a:extLst>
              <a:ext uri="{FF2B5EF4-FFF2-40B4-BE49-F238E27FC236}">
                <a16:creationId xmlns:a16="http://schemas.microsoft.com/office/drawing/2014/main" id="{3957A40A-E610-055A-CB1D-8A7EF60D14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4961" y="-916196"/>
            <a:ext cx="2981992" cy="4100239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DFD87EC9-ABBF-016E-E04A-296738FD05A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11500" y="2499692"/>
            <a:ext cx="2981992" cy="4100239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FDAC8D28-5F92-4B60-ED04-4FA4784FAAF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44961" y="2499692"/>
            <a:ext cx="2981992" cy="4100239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48846515-BEC7-582F-C7A1-B004B3C86388}"/>
              </a:ext>
            </a:extLst>
          </p:cNvPr>
          <p:cNvSpPr txBox="1"/>
          <p:nvPr/>
        </p:nvSpPr>
        <p:spPr>
          <a:xfrm>
            <a:off x="3063897" y="1401417"/>
            <a:ext cx="5195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DRP1                                                                 AKT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D5AACF86-DAD3-E727-DC7F-476D222969EA}"/>
              </a:ext>
            </a:extLst>
          </p:cNvPr>
          <p:cNvSpPr txBox="1"/>
          <p:nvPr/>
        </p:nvSpPr>
        <p:spPr>
          <a:xfrm>
            <a:off x="2759096" y="5599043"/>
            <a:ext cx="6181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p-AKT                                                       GAPDH</a:t>
            </a: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8A1AB116-A4D5-618D-6449-36232EB7E3C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2496" y="655948"/>
            <a:ext cx="4320000" cy="582187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3A5D931D-EA15-9BF8-E1FB-DAA510ED188B}"/>
              </a:ext>
            </a:extLst>
          </p:cNvPr>
          <p:cNvSpPr txBox="1"/>
          <p:nvPr/>
        </p:nvSpPr>
        <p:spPr>
          <a:xfrm>
            <a:off x="269599" y="216213"/>
            <a:ext cx="609517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10C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16307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42140062-3152-02FA-8F2F-FB1C45B2C6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7584" y="3406351"/>
            <a:ext cx="2981992" cy="4100239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96E4CCD7-8072-1E05-59E3-F86BA209061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0574" y="3406350"/>
            <a:ext cx="2981992" cy="4100239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760C1DB9-86C4-5D47-3357-50C5B819FB7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565" y="3406351"/>
            <a:ext cx="2981992" cy="4100239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EF8DBC8-BA49-79AB-2BA7-3C46FAAB9AD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458"/>
          <a:stretch/>
        </p:blipFill>
        <p:spPr>
          <a:xfrm rot="10800000">
            <a:off x="9113597" y="-122498"/>
            <a:ext cx="2981992" cy="338442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C4C99AB-78F1-8B91-7732-F543EFB20226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5490238" y="279932"/>
            <a:ext cx="4100239" cy="298199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3C93FF40-5134-B80A-0E5C-1BC8BB4940E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389999" y="261816"/>
            <a:ext cx="4100239" cy="298199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FB0E458-C160-158D-1358-6868281F9D67}"/>
              </a:ext>
            </a:extLst>
          </p:cNvPr>
          <p:cNvSpPr txBox="1"/>
          <p:nvPr/>
        </p:nvSpPr>
        <p:spPr>
          <a:xfrm>
            <a:off x="1812774" y="6331286"/>
            <a:ext cx="77251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           p-AKT                                   AKT                                            GAPDH</a:t>
            </a: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23039F40-8E55-EACD-6FD4-101C7740A682}"/>
              </a:ext>
            </a:extLst>
          </p:cNvPr>
          <p:cNvSpPr txBox="1"/>
          <p:nvPr/>
        </p:nvSpPr>
        <p:spPr>
          <a:xfrm>
            <a:off x="3307408" y="2759405"/>
            <a:ext cx="80329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RF2                                                    CSE                                             GAPDH</a:t>
            </a: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984FE69E-B510-E029-9A83-AE27D2E5D18C}"/>
              </a:ext>
            </a:extLst>
          </p:cNvPr>
          <p:cNvSpPr txBox="1"/>
          <p:nvPr/>
        </p:nvSpPr>
        <p:spPr>
          <a:xfrm>
            <a:off x="164984" y="279932"/>
            <a:ext cx="12250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10E</a:t>
            </a: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AC496BED-3FBE-AECB-BE61-6CBDEE43BFA0}"/>
              </a:ext>
            </a:extLst>
          </p:cNvPr>
          <p:cNvSpPr/>
          <p:nvPr/>
        </p:nvSpPr>
        <p:spPr>
          <a:xfrm>
            <a:off x="2003466" y="4719597"/>
            <a:ext cx="1303941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BB332A5B-ABDF-7FB4-3DB2-6FDB80A00E08}"/>
              </a:ext>
            </a:extLst>
          </p:cNvPr>
          <p:cNvSpPr/>
          <p:nvPr/>
        </p:nvSpPr>
        <p:spPr>
          <a:xfrm>
            <a:off x="5212169" y="4583761"/>
            <a:ext cx="1303941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FFFC129A-7456-32E4-CEA4-D53C96813EF9}"/>
              </a:ext>
            </a:extLst>
          </p:cNvPr>
          <p:cNvSpPr/>
          <p:nvPr/>
        </p:nvSpPr>
        <p:spPr>
          <a:xfrm>
            <a:off x="8122694" y="5511416"/>
            <a:ext cx="1303941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57286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>
            <a:extLst>
              <a:ext uri="{FF2B5EF4-FFF2-40B4-BE49-F238E27FC236}">
                <a16:creationId xmlns:a16="http://schemas.microsoft.com/office/drawing/2014/main" id="{C43DA09F-FCB5-B154-7A55-D4A564650F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4769" y="3590962"/>
            <a:ext cx="4320000" cy="704531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02CBE108-0715-1A75-DA08-73FAE16F8EE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2097" y="1584262"/>
            <a:ext cx="4680000" cy="65812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47155D00-4EBF-437A-0F56-3526BAF2492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2092" y="342304"/>
            <a:ext cx="2981992" cy="4100239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5411E45-6E77-FD21-15EF-9E75B74A9120}"/>
              </a:ext>
            </a:extLst>
          </p:cNvPr>
          <p:cNvSpPr txBox="1"/>
          <p:nvPr/>
        </p:nvSpPr>
        <p:spPr>
          <a:xfrm>
            <a:off x="4013765" y="2984858"/>
            <a:ext cx="7354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0" i="0" dirty="0">
                <a:solidFill>
                  <a:srgbClr val="10121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ytoplasm: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F2                                                          GAPDH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DCD13B49-AB3A-CF6C-7D72-AAADBC5D5B9D}"/>
              </a:ext>
            </a:extLst>
          </p:cNvPr>
          <p:cNvSpPr/>
          <p:nvPr/>
        </p:nvSpPr>
        <p:spPr>
          <a:xfrm>
            <a:off x="3717223" y="4022337"/>
            <a:ext cx="1302027" cy="464057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CD97B20-B2A9-A921-1686-BB1CAD4F33EF}"/>
              </a:ext>
            </a:extLst>
          </p:cNvPr>
          <p:cNvSpPr txBox="1"/>
          <p:nvPr/>
        </p:nvSpPr>
        <p:spPr>
          <a:xfrm>
            <a:off x="125226" y="657622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1C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566FA524-3EFE-7D45-0BB1-8415756BB4A7}"/>
              </a:ext>
            </a:extLst>
          </p:cNvPr>
          <p:cNvSpPr/>
          <p:nvPr/>
        </p:nvSpPr>
        <p:spPr>
          <a:xfrm>
            <a:off x="9215922" y="2097912"/>
            <a:ext cx="1158162" cy="959842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E6581D11-7E8B-2A47-0117-515A09936A1D}"/>
              </a:ext>
            </a:extLst>
          </p:cNvPr>
          <p:cNvSpPr/>
          <p:nvPr/>
        </p:nvSpPr>
        <p:spPr>
          <a:xfrm>
            <a:off x="5098763" y="1769165"/>
            <a:ext cx="1361661" cy="717538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F76E204D-DD12-2A7E-95C4-0E1A99907AD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6453" y="5144551"/>
            <a:ext cx="4320000" cy="274219"/>
          </a:xfrm>
          <a:prstGeom prst="rect">
            <a:avLst/>
          </a:prstGeom>
        </p:spPr>
      </p:pic>
      <p:sp>
        <p:nvSpPr>
          <p:cNvPr id="32" name="矩形 31">
            <a:extLst>
              <a:ext uri="{FF2B5EF4-FFF2-40B4-BE49-F238E27FC236}">
                <a16:creationId xmlns:a16="http://schemas.microsoft.com/office/drawing/2014/main" id="{05125CA8-6632-568D-858A-FE84B4E7336D}"/>
              </a:ext>
            </a:extLst>
          </p:cNvPr>
          <p:cNvSpPr/>
          <p:nvPr/>
        </p:nvSpPr>
        <p:spPr>
          <a:xfrm>
            <a:off x="3717223" y="5019718"/>
            <a:ext cx="1161211" cy="315734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B6EE5C8F-6CD3-2136-D0DB-3C8D225BE266}"/>
              </a:ext>
            </a:extLst>
          </p:cNvPr>
          <p:cNvSpPr txBox="1"/>
          <p:nvPr/>
        </p:nvSpPr>
        <p:spPr>
          <a:xfrm>
            <a:off x="3798419" y="4650386"/>
            <a:ext cx="5425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0" i="0" dirty="0">
                <a:solidFill>
                  <a:srgbClr val="10121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Nuclear: 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RF2                                                          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583E8D1-54EB-FFAD-D067-AD3E9A3527AB}"/>
              </a:ext>
            </a:extLst>
          </p:cNvPr>
          <p:cNvSpPr txBox="1"/>
          <p:nvPr/>
        </p:nvSpPr>
        <p:spPr>
          <a:xfrm>
            <a:off x="3838175" y="5770121"/>
            <a:ext cx="735495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0" i="0" dirty="0" err="1">
                <a:solidFill>
                  <a:srgbClr val="10121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aimin</a:t>
            </a:r>
            <a:r>
              <a:rPr lang="en-US" altLang="zh-CN" b="0" i="0" dirty="0">
                <a:solidFill>
                  <a:srgbClr val="101214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B1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81081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图片 28">
            <a:extLst>
              <a:ext uri="{FF2B5EF4-FFF2-40B4-BE49-F238E27FC236}">
                <a16:creationId xmlns:a16="http://schemas.microsoft.com/office/drawing/2014/main" id="{11958AE1-E2B4-13A7-C4A9-B7D09F26076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88373" y="118324"/>
            <a:ext cx="2981992" cy="4100239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E0CB3297-E180-732A-EE01-97F25FAA8EE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697"/>
          <a:stretch/>
        </p:blipFill>
        <p:spPr>
          <a:xfrm>
            <a:off x="4148850" y="3817204"/>
            <a:ext cx="2981992" cy="308759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F71B99A-45FB-4AD0-40B7-BDF5009F5105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62" t="-3506" r="762" b="3506"/>
          <a:stretch/>
        </p:blipFill>
        <p:spPr>
          <a:xfrm>
            <a:off x="4080210" y="15693"/>
            <a:ext cx="2981992" cy="410023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9892EA5F-3E45-6835-A147-9085601F525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20150" y="130012"/>
            <a:ext cx="2981992" cy="4100239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69A094C-82D6-C1C2-917E-20BBB756574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163"/>
          <a:stretch/>
        </p:blipFill>
        <p:spPr>
          <a:xfrm>
            <a:off x="1098218" y="3732818"/>
            <a:ext cx="2981992" cy="310949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11E60A40-9527-6409-60BB-EABF0426B313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95"/>
          <a:stretch/>
        </p:blipFill>
        <p:spPr>
          <a:xfrm>
            <a:off x="1079129" y="213691"/>
            <a:ext cx="2981992" cy="3948733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9D720E8A-EA49-57C5-A9C8-E894D91B6CCA}"/>
              </a:ext>
            </a:extLst>
          </p:cNvPr>
          <p:cNvSpPr txBox="1"/>
          <p:nvPr/>
        </p:nvSpPr>
        <p:spPr>
          <a:xfrm>
            <a:off x="1319558" y="2748134"/>
            <a:ext cx="5282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nput:</a:t>
            </a:r>
            <a:r>
              <a:rPr lang="zh-CN" altLang="en-US" dirty="0"/>
              <a:t> </a:t>
            </a:r>
            <a:r>
              <a:rPr lang="en-US" altLang="zh-CN" dirty="0"/>
              <a:t>TOMM70                               </a:t>
            </a:r>
            <a:r>
              <a:rPr lang="en-US" altLang="zh-CN" dirty="0" err="1"/>
              <a:t>CoIP</a:t>
            </a:r>
            <a:r>
              <a:rPr lang="en-US" altLang="zh-CN" dirty="0"/>
              <a:t>: TOMM70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797F0524-4624-228F-AD3C-4272DFA8991D}"/>
              </a:ext>
            </a:extLst>
          </p:cNvPr>
          <p:cNvSpPr txBox="1"/>
          <p:nvPr/>
        </p:nvSpPr>
        <p:spPr>
          <a:xfrm>
            <a:off x="6811017" y="2907195"/>
            <a:ext cx="60502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 Input:</a:t>
            </a:r>
            <a:r>
              <a:rPr lang="zh-CN" altLang="en-US" dirty="0"/>
              <a:t> </a:t>
            </a:r>
            <a:r>
              <a:rPr lang="en-US" altLang="zh-CN" dirty="0"/>
              <a:t>CSE                                                  </a:t>
            </a:r>
            <a:r>
              <a:rPr lang="en-US" altLang="zh-CN" dirty="0" err="1"/>
              <a:t>CoIP</a:t>
            </a:r>
            <a:r>
              <a:rPr lang="en-US" altLang="zh-CN" dirty="0"/>
              <a:t>: CSE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7C94F18-87DE-9358-5AAD-E3BE1B384F8B}"/>
              </a:ext>
            </a:extLst>
          </p:cNvPr>
          <p:cNvSpPr txBox="1"/>
          <p:nvPr/>
        </p:nvSpPr>
        <p:spPr>
          <a:xfrm>
            <a:off x="1641268" y="6414126"/>
            <a:ext cx="5420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nput:</a:t>
            </a:r>
            <a:r>
              <a:rPr lang="zh-CN" altLang="en-US" dirty="0"/>
              <a:t> </a:t>
            </a:r>
            <a:r>
              <a:rPr lang="en-US" altLang="zh-CN" dirty="0"/>
              <a:t>TOMM20                             </a:t>
            </a:r>
            <a:r>
              <a:rPr lang="en-US" altLang="zh-CN" dirty="0" err="1"/>
              <a:t>CoIP</a:t>
            </a:r>
            <a:r>
              <a:rPr lang="en-US" altLang="zh-CN" dirty="0"/>
              <a:t>: TOMM20</a:t>
            </a: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18A01553-54DF-B716-4347-E6DB0C142956}"/>
              </a:ext>
            </a:extLst>
          </p:cNvPr>
          <p:cNvSpPr/>
          <p:nvPr/>
        </p:nvSpPr>
        <p:spPr>
          <a:xfrm>
            <a:off x="1133793" y="1325383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F70982B8-E0F7-0307-A35F-66A81CEF15A3}"/>
              </a:ext>
            </a:extLst>
          </p:cNvPr>
          <p:cNvSpPr/>
          <p:nvPr/>
        </p:nvSpPr>
        <p:spPr>
          <a:xfrm>
            <a:off x="1485711" y="5532617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CF35A8FE-8C6E-6463-2113-7469D1CD2B79}"/>
              </a:ext>
            </a:extLst>
          </p:cNvPr>
          <p:cNvSpPr/>
          <p:nvPr/>
        </p:nvSpPr>
        <p:spPr>
          <a:xfrm>
            <a:off x="7020150" y="2172654"/>
            <a:ext cx="1219200" cy="351745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61696FA-5D0A-2B69-68C0-8413C232ABF6}"/>
              </a:ext>
            </a:extLst>
          </p:cNvPr>
          <p:cNvSpPr txBox="1"/>
          <p:nvPr/>
        </p:nvSpPr>
        <p:spPr>
          <a:xfrm>
            <a:off x="-108348" y="279932"/>
            <a:ext cx="12522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12C</a:t>
            </a: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2F7FC376-09B8-4D32-86FA-23F920A1A203}"/>
              </a:ext>
            </a:extLst>
          </p:cNvPr>
          <p:cNvSpPr/>
          <p:nvPr/>
        </p:nvSpPr>
        <p:spPr>
          <a:xfrm>
            <a:off x="5048570" y="1288054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057F9D99-AD4F-DB38-DD09-39D290AEF5A6}"/>
              </a:ext>
            </a:extLst>
          </p:cNvPr>
          <p:cNvSpPr/>
          <p:nvPr/>
        </p:nvSpPr>
        <p:spPr>
          <a:xfrm>
            <a:off x="5698246" y="5659818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607C0FE4-47A6-D7BE-DB70-D8379AB2F42D}"/>
              </a:ext>
            </a:extLst>
          </p:cNvPr>
          <p:cNvSpPr/>
          <p:nvPr/>
        </p:nvSpPr>
        <p:spPr>
          <a:xfrm>
            <a:off x="10984206" y="2265419"/>
            <a:ext cx="1219200" cy="351745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704083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6A906A4B-5360-1A5E-DEBC-4AF35BC91B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07106" y="1185066"/>
            <a:ext cx="2981992" cy="4100239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75AE9BB2-68E3-1B33-976E-680D3BED8A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24127" y="1185067"/>
            <a:ext cx="2981992" cy="410023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950E63F4-ED22-BAF5-9E57-956A4F1939B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562" y="1185067"/>
            <a:ext cx="2981992" cy="4100239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080582C6-34D9-6B6B-72D3-67CCA6673DB4}"/>
              </a:ext>
            </a:extLst>
          </p:cNvPr>
          <p:cNvSpPr txBox="1"/>
          <p:nvPr/>
        </p:nvSpPr>
        <p:spPr>
          <a:xfrm>
            <a:off x="1008559" y="4858832"/>
            <a:ext cx="87168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OMM70                                      TOMM20                                           CSE</a:t>
            </a: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ED9D70B-3488-F590-B12A-7AF579285D28}"/>
              </a:ext>
            </a:extLst>
          </p:cNvPr>
          <p:cNvSpPr txBox="1"/>
          <p:nvPr/>
        </p:nvSpPr>
        <p:spPr>
          <a:xfrm>
            <a:off x="-73558" y="279932"/>
            <a:ext cx="1220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13F</a:t>
            </a: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9E41A557-5BCA-F427-C3E9-5708594B3F7F}"/>
              </a:ext>
            </a:extLst>
          </p:cNvPr>
          <p:cNvSpPr/>
          <p:nvPr/>
        </p:nvSpPr>
        <p:spPr>
          <a:xfrm>
            <a:off x="1146648" y="3196921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823CC8D8-9841-3B01-4A80-7EC55F281C06}"/>
              </a:ext>
            </a:extLst>
          </p:cNvPr>
          <p:cNvSpPr/>
          <p:nvPr/>
        </p:nvSpPr>
        <p:spPr>
          <a:xfrm>
            <a:off x="4186365" y="3792954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147BA69F-7232-03A8-055C-D8AEFFB20870}"/>
              </a:ext>
            </a:extLst>
          </p:cNvPr>
          <p:cNvSpPr/>
          <p:nvPr/>
        </p:nvSpPr>
        <p:spPr>
          <a:xfrm>
            <a:off x="7409956" y="3274462"/>
            <a:ext cx="1219200" cy="596033"/>
          </a:xfrm>
          <a:prstGeom prst="rect">
            <a:avLst/>
          </a:prstGeom>
          <a:noFill/>
          <a:ln w="25400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19660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ots</Template>
  <TotalTime>251</TotalTime>
  <Words>75</Words>
  <Application>Microsoft Office PowerPoint</Application>
  <PresentationFormat>宽屏</PresentationFormat>
  <Paragraphs>46</Paragraphs>
  <Slides>6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侯 翠兰</dc:creator>
  <cp:lastModifiedBy>侯 翠兰</cp:lastModifiedBy>
  <cp:revision>51</cp:revision>
  <dcterms:created xsi:type="dcterms:W3CDTF">2022-12-03T09:49:24Z</dcterms:created>
  <dcterms:modified xsi:type="dcterms:W3CDTF">2023-07-21T01:15:38Z</dcterms:modified>
</cp:coreProperties>
</file>